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7" d="100"/>
          <a:sy n="67" d="100"/>
        </p:scale>
        <p:origin x="139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D0F7-EF41-44E6-AA02-C142A4799ED9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A618B-327B-4DBE-B63D-7C991C7BA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602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D0F7-EF41-44E6-AA02-C142A4799ED9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A618B-327B-4DBE-B63D-7C991C7BA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4292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D0F7-EF41-44E6-AA02-C142A4799ED9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A618B-327B-4DBE-B63D-7C991C7BA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19368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D0F7-EF41-44E6-AA02-C142A4799ED9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A618B-327B-4DBE-B63D-7C991C7BA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4707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D0F7-EF41-44E6-AA02-C142A4799ED9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A618B-327B-4DBE-B63D-7C991C7BA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0816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D0F7-EF41-44E6-AA02-C142A4799ED9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A618B-327B-4DBE-B63D-7C991C7BA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1815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D0F7-EF41-44E6-AA02-C142A4799ED9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A618B-327B-4DBE-B63D-7C991C7BA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7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D0F7-EF41-44E6-AA02-C142A4799ED9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A618B-327B-4DBE-B63D-7C991C7BA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8541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D0F7-EF41-44E6-AA02-C142A4799ED9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A618B-327B-4DBE-B63D-7C991C7BA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2182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D0F7-EF41-44E6-AA02-C142A4799ED9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A618B-327B-4DBE-B63D-7C991C7BA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395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8D0F7-EF41-44E6-AA02-C142A4799ED9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A618B-327B-4DBE-B63D-7C991C7BA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850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8D0F7-EF41-44E6-AA02-C142A4799ED9}" type="datetimeFigureOut">
              <a:rPr lang="en-US" smtClean="0"/>
              <a:t>5/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DA618B-327B-4DBE-B63D-7C991C7BA8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3278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itle 1"/>
          <p:cNvSpPr txBox="1">
            <a:spLocks/>
          </p:cNvSpPr>
          <p:nvPr/>
        </p:nvSpPr>
        <p:spPr>
          <a:xfrm>
            <a:off x="44263" y="40852"/>
            <a:ext cx="3005839" cy="384153"/>
          </a:xfrm>
          <a:prstGeom prst="rect">
            <a:avLst/>
          </a:prstGeom>
        </p:spPr>
        <p:txBody>
          <a:bodyPr vert="horz" lIns="68580" tIns="34291" rIns="68580" bIns="34291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  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76296543"/>
              </p:ext>
            </p:extLst>
          </p:nvPr>
        </p:nvGraphicFramePr>
        <p:xfrm>
          <a:off x="142875" y="306388"/>
          <a:ext cx="9101138" cy="3733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8" name="Prism 7" r:id="rId3" imgW="8905076" imgH="3733717" progId="Prism7.Document">
                  <p:embed/>
                </p:oleObj>
              </mc:Choice>
              <mc:Fallback>
                <p:oleObj name="Prism 7" r:id="rId3" imgW="8905076" imgH="3733717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2875" y="306388"/>
                        <a:ext cx="9101138" cy="3733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029934" y="3382501"/>
            <a:ext cx="13728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ndothelial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615814" y="3382501"/>
            <a:ext cx="1041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broblast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64519" y="3382501"/>
            <a:ext cx="13728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acrophag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686707" y="3382501"/>
            <a:ext cx="13728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eutrophil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875570" y="3382501"/>
            <a:ext cx="13728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ymphocyte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374462" y="3382501"/>
            <a:ext cx="13728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yocyte</a:t>
            </a:r>
          </a:p>
        </p:txBody>
      </p:sp>
      <p:sp>
        <p:nvSpPr>
          <p:cNvPr id="8" name="Frame 7"/>
          <p:cNvSpPr/>
          <p:nvPr/>
        </p:nvSpPr>
        <p:spPr>
          <a:xfrm>
            <a:off x="709036" y="649765"/>
            <a:ext cx="1402668" cy="3001465"/>
          </a:xfrm>
          <a:prstGeom prst="frame">
            <a:avLst>
              <a:gd name="adj1" fmla="val 0"/>
            </a:avLst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5" name="Frame 14"/>
          <p:cNvSpPr/>
          <p:nvPr/>
        </p:nvSpPr>
        <p:spPr>
          <a:xfrm>
            <a:off x="2118089" y="649764"/>
            <a:ext cx="1323635" cy="3001464"/>
          </a:xfrm>
          <a:prstGeom prst="frame">
            <a:avLst>
              <a:gd name="adj1" fmla="val 0"/>
            </a:avLst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6" name="Frame 15"/>
          <p:cNvSpPr/>
          <p:nvPr/>
        </p:nvSpPr>
        <p:spPr>
          <a:xfrm>
            <a:off x="3432602" y="649764"/>
            <a:ext cx="1398443" cy="3001464"/>
          </a:xfrm>
          <a:prstGeom prst="frame">
            <a:avLst>
              <a:gd name="adj1" fmla="val 0"/>
            </a:avLst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5" name="Frame 24"/>
          <p:cNvSpPr/>
          <p:nvPr/>
        </p:nvSpPr>
        <p:spPr>
          <a:xfrm>
            <a:off x="4831045" y="649762"/>
            <a:ext cx="1314513" cy="3001466"/>
          </a:xfrm>
          <a:prstGeom prst="frame">
            <a:avLst>
              <a:gd name="adj1" fmla="val 0"/>
            </a:avLst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6" name="Frame 25"/>
          <p:cNvSpPr/>
          <p:nvPr/>
        </p:nvSpPr>
        <p:spPr>
          <a:xfrm>
            <a:off x="6145558" y="649764"/>
            <a:ext cx="1391171" cy="3001464"/>
          </a:xfrm>
          <a:prstGeom prst="frame">
            <a:avLst>
              <a:gd name="adj1" fmla="val 0"/>
            </a:avLst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7" name="Frame 26"/>
          <p:cNvSpPr/>
          <p:nvPr/>
        </p:nvSpPr>
        <p:spPr>
          <a:xfrm>
            <a:off x="7536728" y="649765"/>
            <a:ext cx="1368470" cy="3001465"/>
          </a:xfrm>
          <a:prstGeom prst="frame">
            <a:avLst>
              <a:gd name="adj1" fmla="val 0"/>
            </a:avLst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graphicFrame>
        <p:nvGraphicFramePr>
          <p:cNvPr id="93" name="Object 9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9811085"/>
              </p:ext>
            </p:extLst>
          </p:nvPr>
        </p:nvGraphicFramePr>
        <p:xfrm>
          <a:off x="602623" y="3951880"/>
          <a:ext cx="8110537" cy="2533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9" name="Prism 7" r:id="rId5" imgW="9147447" imgH="2579783" progId="Prism7.Document">
                  <p:embed/>
                </p:oleObj>
              </mc:Choice>
              <mc:Fallback>
                <p:oleObj name="Prism 7" r:id="rId5" imgW="9147447" imgH="2579783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02623" y="3951880"/>
                        <a:ext cx="8110537" cy="2533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5" name="TextBox 124"/>
          <p:cNvSpPr txBox="1"/>
          <p:nvPr/>
        </p:nvSpPr>
        <p:spPr>
          <a:xfrm>
            <a:off x="6325039" y="6103019"/>
            <a:ext cx="8753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Itgam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3699633" y="6103019"/>
            <a:ext cx="8753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mr1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2409115" y="6103019"/>
            <a:ext cx="8753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d68</a:t>
            </a:r>
          </a:p>
        </p:txBody>
      </p:sp>
      <p:sp>
        <p:nvSpPr>
          <p:cNvPr id="128" name="TextBox 127"/>
          <p:cNvSpPr txBox="1"/>
          <p:nvPr/>
        </p:nvSpPr>
        <p:spPr>
          <a:xfrm>
            <a:off x="7646077" y="6103019"/>
            <a:ext cx="8753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gals3</a:t>
            </a:r>
          </a:p>
        </p:txBody>
      </p:sp>
      <p:sp>
        <p:nvSpPr>
          <p:cNvPr id="129" name="TextBox 128"/>
          <p:cNvSpPr txBox="1"/>
          <p:nvPr/>
        </p:nvSpPr>
        <p:spPr>
          <a:xfrm>
            <a:off x="1068612" y="6103019"/>
            <a:ext cx="8753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5012336" y="6103019"/>
            <a:ext cx="8753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cgr3</a:t>
            </a:r>
          </a:p>
        </p:txBody>
      </p:sp>
      <p:sp>
        <p:nvSpPr>
          <p:cNvPr id="136" name="TextBox 135"/>
          <p:cNvSpPr txBox="1"/>
          <p:nvPr/>
        </p:nvSpPr>
        <p:spPr>
          <a:xfrm rot="16200000">
            <a:off x="-351623" y="4949787"/>
            <a:ext cx="9964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FPKM</a:t>
            </a:r>
          </a:p>
        </p:txBody>
      </p:sp>
      <p:sp>
        <p:nvSpPr>
          <p:cNvPr id="137" name="TextBox 136"/>
          <p:cNvSpPr txBox="1"/>
          <p:nvPr/>
        </p:nvSpPr>
        <p:spPr>
          <a:xfrm rot="16200000">
            <a:off x="-351623" y="1593981"/>
            <a:ext cx="9964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FPKM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1125043" y="4416321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1401092" y="4881857"/>
            <a:ext cx="12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1613641" y="4538958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1776001" y="4565391"/>
            <a:ext cx="12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$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2925939" y="5214975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3066277" y="5251579"/>
            <a:ext cx="12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3757654" y="5720558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4025510" y="5508907"/>
            <a:ext cx="1402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4247681" y="5303068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4495713" y="5318498"/>
            <a:ext cx="12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$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4380648" y="5307308"/>
            <a:ext cx="12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6388705" y="5395442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6595375" y="5497516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6744278" y="5522680"/>
            <a:ext cx="12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6843081" y="5691957"/>
            <a:ext cx="1702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6997363" y="5685272"/>
            <a:ext cx="12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$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7691122" y="4207952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7965678" y="4180620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8237789" y="4193759"/>
            <a:ext cx="127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" name="Left Brace 2"/>
          <p:cNvSpPr/>
          <p:nvPr/>
        </p:nvSpPr>
        <p:spPr>
          <a:xfrm rot="16200000">
            <a:off x="1140490" y="3267586"/>
            <a:ext cx="463504" cy="1353431"/>
          </a:xfrm>
          <a:prstGeom prst="leftBrace">
            <a:avLst>
              <a:gd name="adj1" fmla="val 8333"/>
              <a:gd name="adj2" fmla="val 50476"/>
            </a:avLst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TextBox 44"/>
          <p:cNvSpPr txBox="1"/>
          <p:nvPr/>
        </p:nvSpPr>
        <p:spPr>
          <a:xfrm>
            <a:off x="453468" y="2674769"/>
            <a:ext cx="2945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51388" y="1995243"/>
            <a:ext cx="596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151388" y="1261877"/>
            <a:ext cx="596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51388" y="567990"/>
            <a:ext cx="596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53468" y="5951850"/>
            <a:ext cx="2945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151388" y="5367860"/>
            <a:ext cx="596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51388" y="4757326"/>
            <a:ext cx="596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51388" y="4186263"/>
            <a:ext cx="596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6841136" y="4036626"/>
            <a:ext cx="1041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0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6837603" y="4301790"/>
            <a:ext cx="1041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6837602" y="4544368"/>
            <a:ext cx="1041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3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6835758" y="4790351"/>
            <a:ext cx="10411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7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68356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</TotalTime>
  <Words>52</Words>
  <Application>Microsoft Office PowerPoint</Application>
  <PresentationFormat>On-screen Show (4:3)</PresentationFormat>
  <Paragraphs>4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7</vt:lpstr>
      <vt:lpstr>GraphPad Prism 7 Project</vt:lpstr>
      <vt:lpstr>PowerPoint Presentation</vt:lpstr>
    </vt:vector>
  </TitlesOfParts>
  <Company>UMM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Mouton</dc:creator>
  <cp:lastModifiedBy>Alan Mouton</cp:lastModifiedBy>
  <cp:revision>15</cp:revision>
  <dcterms:created xsi:type="dcterms:W3CDTF">2018-03-06T20:15:06Z</dcterms:created>
  <dcterms:modified xsi:type="dcterms:W3CDTF">2018-05-09T18:45:48Z</dcterms:modified>
</cp:coreProperties>
</file>